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392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7186673"/>
              </p:ext>
            </p:extLst>
          </p:nvPr>
        </p:nvGraphicFramePr>
        <p:xfrm>
          <a:off x="4633981" y="2145779"/>
          <a:ext cx="2173491" cy="22185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2716864" imgH="2773186" progId="Prism6.Document">
                  <p:embed/>
                </p:oleObj>
              </mc:Choice>
              <mc:Fallback>
                <p:oleObj name="Prism 6" r:id="rId3" imgW="2716864" imgH="2773186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3981" y="2145779"/>
                        <a:ext cx="2173491" cy="221854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3622601"/>
              </p:ext>
            </p:extLst>
          </p:nvPr>
        </p:nvGraphicFramePr>
        <p:xfrm>
          <a:off x="2231065" y="2145779"/>
          <a:ext cx="2173288" cy="2219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6" r:id="rId5" imgW="2716864" imgH="2773186" progId="Prism6.Document">
                  <p:embed/>
                </p:oleObj>
              </mc:Choice>
              <mc:Fallback>
                <p:oleObj name="Prism 6" r:id="rId5" imgW="2716864" imgH="2773186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31065" y="2145779"/>
                        <a:ext cx="2173288" cy="22193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 rot="10800000" flipV="1">
            <a:off x="2133818" y="1619679"/>
            <a:ext cx="7401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000" b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8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1</a:t>
            </a:r>
            <a:endParaRPr lang="zh-CN" altLang="en-US" sz="8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0800000" flipV="1">
            <a:off x="1979713" y="1879026"/>
            <a:ext cx="8942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100" b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8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8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3"/>
          <p:cNvSpPr txBox="1"/>
          <p:nvPr/>
        </p:nvSpPr>
        <p:spPr>
          <a:xfrm>
            <a:off x="3141931" y="2994467"/>
            <a:ext cx="351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3"/>
          <p:cNvSpPr txBox="1"/>
          <p:nvPr/>
        </p:nvSpPr>
        <p:spPr>
          <a:xfrm>
            <a:off x="3382389" y="2861339"/>
            <a:ext cx="415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3"/>
          <p:cNvSpPr txBox="1"/>
          <p:nvPr/>
        </p:nvSpPr>
        <p:spPr>
          <a:xfrm>
            <a:off x="3698946" y="2986712"/>
            <a:ext cx="3864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3"/>
          <p:cNvSpPr txBox="1"/>
          <p:nvPr/>
        </p:nvSpPr>
        <p:spPr>
          <a:xfrm>
            <a:off x="5522875" y="3094434"/>
            <a:ext cx="351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3"/>
          <p:cNvSpPr txBox="1"/>
          <p:nvPr/>
        </p:nvSpPr>
        <p:spPr>
          <a:xfrm>
            <a:off x="5815952" y="2861339"/>
            <a:ext cx="415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2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3"/>
          <p:cNvSpPr txBox="1"/>
          <p:nvPr/>
        </p:nvSpPr>
        <p:spPr>
          <a:xfrm>
            <a:off x="6023493" y="3085372"/>
            <a:ext cx="560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33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组合 17"/>
          <p:cNvGrpSpPr/>
          <p:nvPr/>
        </p:nvGrpSpPr>
        <p:grpSpPr>
          <a:xfrm>
            <a:off x="4263913" y="1619679"/>
            <a:ext cx="894242" cy="474791"/>
            <a:chOff x="3203849" y="1586057"/>
            <a:chExt cx="894242" cy="474791"/>
          </a:xfrm>
        </p:grpSpPr>
        <p:sp>
          <p:nvSpPr>
            <p:cNvPr id="15" name="TextBox 14"/>
            <p:cNvSpPr txBox="1"/>
            <p:nvPr/>
          </p:nvSpPr>
          <p:spPr>
            <a:xfrm rot="10800000" flipV="1">
              <a:off x="3203849" y="1586057"/>
              <a:ext cx="7401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r">
                <a:defRPr sz="1000" b="1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800" b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KD</a:t>
              </a:r>
              <a:endParaRPr lang="zh-CN" altLang="en-US" sz="800" b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0800000" flipV="1">
              <a:off x="3203849" y="1845404"/>
              <a:ext cx="894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r">
                <a:defRPr sz="1100" b="1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lvl1pPr>
            </a:lstStyle>
            <a:p>
              <a:pPr algn="l"/>
              <a:r>
                <a:rPr lang="en-US" altLang="zh-CN" sz="800" b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KD</a:t>
              </a:r>
              <a:endParaRPr lang="zh-CN" altLang="en-US" sz="800" b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3420532" y="4221668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(a)</a:t>
            </a:r>
            <a:endParaRPr lang="zh-CN" altLang="en-US" sz="8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34219" y="4221668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(b)</a:t>
            </a:r>
            <a:endParaRPr lang="zh-CN" altLang="en-US" sz="8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" name="TextBox 3"/>
          <p:cNvSpPr txBox="1"/>
          <p:nvPr/>
        </p:nvSpPr>
        <p:spPr>
          <a:xfrm>
            <a:off x="4005884" y="2867066"/>
            <a:ext cx="3596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6303783" y="2779023"/>
            <a:ext cx="560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2244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Picture 110"/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6382" y="1879026"/>
            <a:ext cx="1440000" cy="18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2" name="Picture 119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6382" y="1637401"/>
            <a:ext cx="1440000" cy="1800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3" name="矩形 1"/>
          <p:cNvSpPr/>
          <p:nvPr/>
        </p:nvSpPr>
        <p:spPr>
          <a:xfrm>
            <a:off x="1117860" y="4653136"/>
            <a:ext cx="662249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Expression and activity of SIRT1 protein in glomerular epithelial cells after CLP.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1836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3"/>
          <p:cNvGrpSpPr/>
          <p:nvPr/>
        </p:nvGrpSpPr>
        <p:grpSpPr>
          <a:xfrm>
            <a:off x="580948" y="2041525"/>
            <a:ext cx="8239524" cy="2322999"/>
            <a:chOff x="580948" y="2041525"/>
            <a:chExt cx="8239524" cy="2322999"/>
          </a:xfrm>
        </p:grpSpPr>
        <p:graphicFrame>
          <p:nvGraphicFramePr>
            <p:cNvPr id="3" name="对象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5126755"/>
                </p:ext>
              </p:extLst>
            </p:nvPr>
          </p:nvGraphicFramePr>
          <p:xfrm>
            <a:off x="4816797" y="2060848"/>
            <a:ext cx="4003675" cy="19510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0" name="Prism 6" r:id="rId3" imgW="5003726" imgH="2437883" progId="Prism6.Document">
                    <p:embed/>
                  </p:oleObj>
                </mc:Choice>
                <mc:Fallback>
                  <p:oleObj name="Prism 6" r:id="rId3" imgW="5003726" imgH="2437883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816797" y="2060848"/>
                          <a:ext cx="4003675" cy="19510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对象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75787323"/>
                </p:ext>
              </p:extLst>
            </p:nvPr>
          </p:nvGraphicFramePr>
          <p:xfrm>
            <a:off x="2771800" y="2060575"/>
            <a:ext cx="2005236" cy="22185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1" name="Prism 6" r:id="rId5" imgW="2506545" imgH="2773186" progId="Prism6.Document">
                    <p:embed/>
                  </p:oleObj>
                </mc:Choice>
                <mc:Fallback>
                  <p:oleObj name="Prism 6" r:id="rId5" imgW="2506545" imgH="2773186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771800" y="2060575"/>
                          <a:ext cx="2005236" cy="221854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8646912"/>
                </p:ext>
              </p:extLst>
            </p:nvPr>
          </p:nvGraphicFramePr>
          <p:xfrm>
            <a:off x="580948" y="2041525"/>
            <a:ext cx="2027132" cy="22185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2" name="Prism 6" r:id="rId7" imgW="2533915" imgH="2773186" progId="Prism6.Document">
                    <p:embed/>
                  </p:oleObj>
                </mc:Choice>
                <mc:Fallback>
                  <p:oleObj name="Prism 6" r:id="rId7" imgW="2533915" imgH="2773186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80948" y="2041525"/>
                          <a:ext cx="2027132" cy="2218549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3"/>
            <p:cNvSpPr txBox="1"/>
            <p:nvPr/>
          </p:nvSpPr>
          <p:spPr>
            <a:xfrm>
              <a:off x="1445044" y="2439234"/>
              <a:ext cx="3515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3"/>
            <p:cNvSpPr txBox="1"/>
            <p:nvPr/>
          </p:nvSpPr>
          <p:spPr>
            <a:xfrm>
              <a:off x="1788120" y="2997532"/>
              <a:ext cx="4150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3"/>
            <p:cNvSpPr txBox="1"/>
            <p:nvPr/>
          </p:nvSpPr>
          <p:spPr>
            <a:xfrm>
              <a:off x="2067201" y="2223790"/>
              <a:ext cx="5605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3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3"/>
            <p:cNvSpPr txBox="1"/>
            <p:nvPr/>
          </p:nvSpPr>
          <p:spPr>
            <a:xfrm>
              <a:off x="3599871" y="2257946"/>
              <a:ext cx="3515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3"/>
            <p:cNvSpPr txBox="1"/>
            <p:nvPr/>
          </p:nvSpPr>
          <p:spPr>
            <a:xfrm>
              <a:off x="3951428" y="2900518"/>
              <a:ext cx="4150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3"/>
            <p:cNvSpPr txBox="1"/>
            <p:nvPr/>
          </p:nvSpPr>
          <p:spPr>
            <a:xfrm>
              <a:off x="4214166" y="2223790"/>
              <a:ext cx="5605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3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976558" y="3671446"/>
              <a:ext cx="3321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 smtClean="0">
                  <a:solidFill>
                    <a:srgbClr val="0000A0"/>
                  </a:solidFill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···</a:t>
              </a:r>
              <a:endParaRPr lang="zh-CN" altLang="en-US" sz="1100" dirty="0">
                <a:solidFill>
                  <a:srgbClr val="0000A0"/>
                </a:solidFill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796532" y="2565484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solidFill>
                    <a:srgbClr val="FFA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zh-CN" altLang="en-US" sz="800" dirty="0">
                <a:solidFill>
                  <a:srgbClr val="FFA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156569" y="3212976"/>
              <a:ext cx="5040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solidFill>
                    <a:srgbClr val="00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33</a:t>
              </a:r>
              <a:endParaRPr lang="zh-CN" altLang="en-US" sz="800" dirty="0">
                <a:solidFill>
                  <a:srgbClr val="00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300585" y="2675599"/>
              <a:ext cx="5040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solidFill>
                    <a:srgbClr val="C0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22</a:t>
              </a:r>
              <a:endParaRPr lang="zh-CN" altLang="en-US" sz="800" dirty="0">
                <a:solidFill>
                  <a:srgbClr val="C0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619672" y="4149080"/>
              <a:ext cx="303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(a)</a:t>
              </a:r>
              <a:endParaRPr lang="zh-CN" altLang="en-US" sz="8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851920" y="4149080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(b)</a:t>
              </a:r>
              <a:endParaRPr lang="zh-CN" altLang="en-US" sz="8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372200" y="4149080"/>
              <a:ext cx="2968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(c)</a:t>
              </a:r>
              <a:endParaRPr lang="zh-CN" altLang="en-US" sz="8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矩形 4"/>
          <p:cNvSpPr/>
          <p:nvPr/>
        </p:nvSpPr>
        <p:spPr>
          <a:xfrm>
            <a:off x="683567" y="4509120"/>
            <a:ext cx="645906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Creatinine and urea nitrogen levels, and survival time of rats after CLP.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5445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On-screen Show (4:3)</PresentationFormat>
  <Paragraphs>29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Prism 6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a Mohamed</dc:creator>
  <cp:lastModifiedBy>Staff</cp:lastModifiedBy>
  <cp:revision>1</cp:revision>
  <dcterms:created xsi:type="dcterms:W3CDTF">2006-08-16T00:00:00Z</dcterms:created>
  <dcterms:modified xsi:type="dcterms:W3CDTF">2016-11-01T09:24:55Z</dcterms:modified>
</cp:coreProperties>
</file>